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89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DD372-44E1-4569-B3B0-C2EBBECA986B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C453F-A5FC-49AA-B43D-C829393FD93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DD372-44E1-4569-B3B0-C2EBBECA986B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C453F-A5FC-49AA-B43D-C829393FD93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DD372-44E1-4569-B3B0-C2EBBECA986B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C453F-A5FC-49AA-B43D-C829393FD93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DD372-44E1-4569-B3B0-C2EBBECA986B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C453F-A5FC-49AA-B43D-C829393FD93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DD372-44E1-4569-B3B0-C2EBBECA986B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C453F-A5FC-49AA-B43D-C829393FD93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DD372-44E1-4569-B3B0-C2EBBECA986B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C453F-A5FC-49AA-B43D-C829393FD93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DD372-44E1-4569-B3B0-C2EBBECA986B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C453F-A5FC-49AA-B43D-C829393FD93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DD372-44E1-4569-B3B0-C2EBBECA986B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C453F-A5FC-49AA-B43D-C829393FD93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DD372-44E1-4569-B3B0-C2EBBECA986B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C453F-A5FC-49AA-B43D-C829393FD93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DD372-44E1-4569-B3B0-C2EBBECA986B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C453F-A5FC-49AA-B43D-C829393FD93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DD372-44E1-4569-B3B0-C2EBBECA986B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C453F-A5FC-49AA-B43D-C829393FD93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FDD372-44E1-4569-B3B0-C2EBBECA986B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C453F-A5FC-49AA-B43D-C829393FD937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914403" y="914398"/>
          <a:ext cx="7391395" cy="5029204"/>
        </p:xfrm>
        <a:graphic>
          <a:graphicData uri="http://schemas.openxmlformats.org/drawingml/2006/table">
            <a:tbl>
              <a:tblPr/>
              <a:tblGrid>
                <a:gridCol w="2006045"/>
                <a:gridCol w="538535"/>
                <a:gridCol w="538535"/>
                <a:gridCol w="538535"/>
                <a:gridCol w="538535"/>
                <a:gridCol w="538535"/>
                <a:gridCol w="538535"/>
                <a:gridCol w="538535"/>
                <a:gridCol w="538535"/>
                <a:gridCol w="538535"/>
                <a:gridCol w="538535"/>
              </a:tblGrid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aa position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2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3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# of epitop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Arial"/>
                        </a:rPr>
                        <a:t>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Percent of total epitop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7.9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3.2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.8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.6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.6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9.0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30.2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3.2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1.1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7.5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aa position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5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6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6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Arial"/>
                        </a:rPr>
                        <a:t>6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6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6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6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7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7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7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# of epitop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2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2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Percent of total epitop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6.3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36.5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6.3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39.7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latin typeface="Arial"/>
                        </a:rPr>
                        <a:t>9.5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1.1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27.0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7.5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3.2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7.9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aa position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7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7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7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7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8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8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8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9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9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0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# of epitop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2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2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Percent of total epitop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3.2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1.3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.8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1.1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1.3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2.7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4.3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7.5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.6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.6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aa position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0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0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2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3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3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4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4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4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4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4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# of epitop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Percent of total epitop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.6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9.5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7.5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9.5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.8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7.9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4.3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2.7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3.2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7.5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aa position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5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5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5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5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5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6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6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6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6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7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# of epitop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3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Percent of total epitop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.8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1.1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7.9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.8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2.7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.6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9.2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4.3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9.0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.6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aa position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7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7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8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9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25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26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D8D8"/>
                    </a:solidFill>
                  </a:tcPr>
                </a:tc>
              </a:tr>
              <a:tr h="218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# of epitop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66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latin typeface="Arial"/>
                        </a:rPr>
                        <a:t>Percent of total epitop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6.3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.6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4.8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.6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.6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latin typeface="Arial"/>
                        </a:rPr>
                        <a:t>1.6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latin typeface="Arial"/>
                        </a:rPr>
                        <a:t> 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1265" name="Rectangle 1"/>
          <p:cNvSpPr>
            <a:spLocks noChangeArrowheads="1"/>
          </p:cNvSpPr>
          <p:nvPr/>
        </p:nvSpPr>
        <p:spPr bwMode="auto">
          <a:xfrm>
            <a:off x="0" y="74711"/>
            <a:ext cx="645805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Table D.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Amino acid positions and number of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epitopes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defined by each position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92</Words>
  <Application>Microsoft Office PowerPoint</Application>
  <PresentationFormat>On-screen Show (4:3)</PresentationFormat>
  <Paragraphs>25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dim</dc:creator>
  <cp:lastModifiedBy>Nadim</cp:lastModifiedBy>
  <cp:revision>1</cp:revision>
  <dcterms:created xsi:type="dcterms:W3CDTF">2017-03-12T04:48:13Z</dcterms:created>
  <dcterms:modified xsi:type="dcterms:W3CDTF">2017-03-12T04:49:38Z</dcterms:modified>
</cp:coreProperties>
</file>